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8135938" cy="115204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00" autoAdjust="0"/>
    <p:restoredTop sz="94660"/>
  </p:normalViewPr>
  <p:slideViewPr>
    <p:cSldViewPr snapToGrid="0">
      <p:cViewPr varScale="1">
        <p:scale>
          <a:sx n="57" d="100"/>
          <a:sy n="57" d="100"/>
        </p:scale>
        <p:origin x="2180" y="1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10196" y="1885414"/>
            <a:ext cx="6915547" cy="4010837"/>
          </a:xfrm>
        </p:spPr>
        <p:txBody>
          <a:bodyPr anchor="b"/>
          <a:lstStyle>
            <a:lvl1pPr algn="ctr">
              <a:defRPr sz="533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16992" y="6050924"/>
            <a:ext cx="6101954" cy="2781450"/>
          </a:xfrm>
        </p:spPr>
        <p:txBody>
          <a:bodyPr/>
          <a:lstStyle>
            <a:lvl1pPr marL="0" indent="0" algn="ctr">
              <a:buNone/>
              <a:defRPr sz="2136"/>
            </a:lvl1pPr>
            <a:lvl2pPr marL="406817" indent="0" algn="ctr">
              <a:buNone/>
              <a:defRPr sz="1780"/>
            </a:lvl2pPr>
            <a:lvl3pPr marL="813633" indent="0" algn="ctr">
              <a:buNone/>
              <a:defRPr sz="1602"/>
            </a:lvl3pPr>
            <a:lvl4pPr marL="1220450" indent="0" algn="ctr">
              <a:buNone/>
              <a:defRPr sz="1424"/>
            </a:lvl4pPr>
            <a:lvl5pPr marL="1627266" indent="0" algn="ctr">
              <a:buNone/>
              <a:defRPr sz="1424"/>
            </a:lvl5pPr>
            <a:lvl6pPr marL="2034083" indent="0" algn="ctr">
              <a:buNone/>
              <a:defRPr sz="1424"/>
            </a:lvl6pPr>
            <a:lvl7pPr marL="2440899" indent="0" algn="ctr">
              <a:buNone/>
              <a:defRPr sz="1424"/>
            </a:lvl7pPr>
            <a:lvl8pPr marL="2847716" indent="0" algn="ctr">
              <a:buNone/>
              <a:defRPr sz="1424"/>
            </a:lvl8pPr>
            <a:lvl9pPr marL="3254532" indent="0" algn="ctr">
              <a:buNone/>
              <a:defRPr sz="1424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F94E3-3E99-4D87-8C79-4DA52A3888F2}" type="datetimeFigureOut">
              <a:rPr kumimoji="1" lang="ja-JP" altLang="en-US" smtClean="0"/>
              <a:t>2025/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46D73-5B25-4656-9AC0-ECFDA40330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84296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F94E3-3E99-4D87-8C79-4DA52A3888F2}" type="datetimeFigureOut">
              <a:rPr kumimoji="1" lang="ja-JP" altLang="en-US" smtClean="0"/>
              <a:t>2025/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46D73-5B25-4656-9AC0-ECFDA40330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0235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822281" y="613359"/>
            <a:ext cx="1754312" cy="9763081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59346" y="613359"/>
            <a:ext cx="5161236" cy="9763081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F94E3-3E99-4D87-8C79-4DA52A3888F2}" type="datetimeFigureOut">
              <a:rPr kumimoji="1" lang="ja-JP" altLang="en-US" smtClean="0"/>
              <a:t>2025/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46D73-5B25-4656-9AC0-ECFDA40330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5274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F94E3-3E99-4D87-8C79-4DA52A3888F2}" type="datetimeFigureOut">
              <a:rPr kumimoji="1" lang="ja-JP" altLang="en-US" smtClean="0"/>
              <a:t>2025/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46D73-5B25-4656-9AC0-ECFDA40330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14968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55108" y="2872125"/>
            <a:ext cx="7017247" cy="4792202"/>
          </a:xfrm>
        </p:spPr>
        <p:txBody>
          <a:bodyPr anchor="b"/>
          <a:lstStyle>
            <a:lvl1pPr>
              <a:defRPr sz="533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55108" y="7709663"/>
            <a:ext cx="7017247" cy="2520106"/>
          </a:xfrm>
        </p:spPr>
        <p:txBody>
          <a:bodyPr/>
          <a:lstStyle>
            <a:lvl1pPr marL="0" indent="0">
              <a:buNone/>
              <a:defRPr sz="2136">
                <a:solidFill>
                  <a:schemeClr val="tx1"/>
                </a:solidFill>
              </a:defRPr>
            </a:lvl1pPr>
            <a:lvl2pPr marL="406817" indent="0">
              <a:buNone/>
              <a:defRPr sz="1780">
                <a:solidFill>
                  <a:schemeClr val="tx1">
                    <a:tint val="75000"/>
                  </a:schemeClr>
                </a:solidFill>
              </a:defRPr>
            </a:lvl2pPr>
            <a:lvl3pPr marL="813633" indent="0">
              <a:buNone/>
              <a:defRPr sz="1602">
                <a:solidFill>
                  <a:schemeClr val="tx1">
                    <a:tint val="75000"/>
                  </a:schemeClr>
                </a:solidFill>
              </a:defRPr>
            </a:lvl3pPr>
            <a:lvl4pPr marL="1220450" indent="0">
              <a:buNone/>
              <a:defRPr sz="1424">
                <a:solidFill>
                  <a:schemeClr val="tx1">
                    <a:tint val="75000"/>
                  </a:schemeClr>
                </a:solidFill>
              </a:defRPr>
            </a:lvl4pPr>
            <a:lvl5pPr marL="1627266" indent="0">
              <a:buNone/>
              <a:defRPr sz="1424">
                <a:solidFill>
                  <a:schemeClr val="tx1">
                    <a:tint val="75000"/>
                  </a:schemeClr>
                </a:solidFill>
              </a:defRPr>
            </a:lvl5pPr>
            <a:lvl6pPr marL="2034083" indent="0">
              <a:buNone/>
              <a:defRPr sz="1424">
                <a:solidFill>
                  <a:schemeClr val="tx1">
                    <a:tint val="75000"/>
                  </a:schemeClr>
                </a:solidFill>
              </a:defRPr>
            </a:lvl6pPr>
            <a:lvl7pPr marL="2440899" indent="0">
              <a:buNone/>
              <a:defRPr sz="1424">
                <a:solidFill>
                  <a:schemeClr val="tx1">
                    <a:tint val="75000"/>
                  </a:schemeClr>
                </a:solidFill>
              </a:defRPr>
            </a:lvl7pPr>
            <a:lvl8pPr marL="2847716" indent="0">
              <a:buNone/>
              <a:defRPr sz="1424">
                <a:solidFill>
                  <a:schemeClr val="tx1">
                    <a:tint val="75000"/>
                  </a:schemeClr>
                </a:solidFill>
              </a:defRPr>
            </a:lvl8pPr>
            <a:lvl9pPr marL="3254532" indent="0">
              <a:buNone/>
              <a:defRPr sz="142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F94E3-3E99-4D87-8C79-4DA52A3888F2}" type="datetimeFigureOut">
              <a:rPr kumimoji="1" lang="ja-JP" altLang="en-US" smtClean="0"/>
              <a:t>2025/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46D73-5B25-4656-9AC0-ECFDA40330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5131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59346" y="3066796"/>
            <a:ext cx="3457774" cy="730964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18818" y="3066796"/>
            <a:ext cx="3457774" cy="730964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F94E3-3E99-4D87-8C79-4DA52A3888F2}" type="datetimeFigureOut">
              <a:rPr kumimoji="1" lang="ja-JP" altLang="en-US" smtClean="0"/>
              <a:t>2025/2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46D73-5B25-4656-9AC0-ECFDA40330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08773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0405" y="613362"/>
            <a:ext cx="7017247" cy="222676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0406" y="2824120"/>
            <a:ext cx="3441883" cy="1384058"/>
          </a:xfrm>
        </p:spPr>
        <p:txBody>
          <a:bodyPr anchor="b"/>
          <a:lstStyle>
            <a:lvl1pPr marL="0" indent="0">
              <a:buNone/>
              <a:defRPr sz="2136" b="1"/>
            </a:lvl1pPr>
            <a:lvl2pPr marL="406817" indent="0">
              <a:buNone/>
              <a:defRPr sz="1780" b="1"/>
            </a:lvl2pPr>
            <a:lvl3pPr marL="813633" indent="0">
              <a:buNone/>
              <a:defRPr sz="1602" b="1"/>
            </a:lvl3pPr>
            <a:lvl4pPr marL="1220450" indent="0">
              <a:buNone/>
              <a:defRPr sz="1424" b="1"/>
            </a:lvl4pPr>
            <a:lvl5pPr marL="1627266" indent="0">
              <a:buNone/>
              <a:defRPr sz="1424" b="1"/>
            </a:lvl5pPr>
            <a:lvl6pPr marL="2034083" indent="0">
              <a:buNone/>
              <a:defRPr sz="1424" b="1"/>
            </a:lvl6pPr>
            <a:lvl7pPr marL="2440899" indent="0">
              <a:buNone/>
              <a:defRPr sz="1424" b="1"/>
            </a:lvl7pPr>
            <a:lvl8pPr marL="2847716" indent="0">
              <a:buNone/>
              <a:defRPr sz="1424" b="1"/>
            </a:lvl8pPr>
            <a:lvl9pPr marL="3254532" indent="0">
              <a:buNone/>
              <a:defRPr sz="142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60406" y="4208178"/>
            <a:ext cx="3441883" cy="618959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118819" y="2824120"/>
            <a:ext cx="3458833" cy="1384058"/>
          </a:xfrm>
        </p:spPr>
        <p:txBody>
          <a:bodyPr anchor="b"/>
          <a:lstStyle>
            <a:lvl1pPr marL="0" indent="0">
              <a:buNone/>
              <a:defRPr sz="2136" b="1"/>
            </a:lvl1pPr>
            <a:lvl2pPr marL="406817" indent="0">
              <a:buNone/>
              <a:defRPr sz="1780" b="1"/>
            </a:lvl2pPr>
            <a:lvl3pPr marL="813633" indent="0">
              <a:buNone/>
              <a:defRPr sz="1602" b="1"/>
            </a:lvl3pPr>
            <a:lvl4pPr marL="1220450" indent="0">
              <a:buNone/>
              <a:defRPr sz="1424" b="1"/>
            </a:lvl4pPr>
            <a:lvl5pPr marL="1627266" indent="0">
              <a:buNone/>
              <a:defRPr sz="1424" b="1"/>
            </a:lvl5pPr>
            <a:lvl6pPr marL="2034083" indent="0">
              <a:buNone/>
              <a:defRPr sz="1424" b="1"/>
            </a:lvl6pPr>
            <a:lvl7pPr marL="2440899" indent="0">
              <a:buNone/>
              <a:defRPr sz="1424" b="1"/>
            </a:lvl7pPr>
            <a:lvl8pPr marL="2847716" indent="0">
              <a:buNone/>
              <a:defRPr sz="1424" b="1"/>
            </a:lvl8pPr>
            <a:lvl9pPr marL="3254532" indent="0">
              <a:buNone/>
              <a:defRPr sz="142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118819" y="4208178"/>
            <a:ext cx="3458833" cy="618959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F94E3-3E99-4D87-8C79-4DA52A3888F2}" type="datetimeFigureOut">
              <a:rPr kumimoji="1" lang="ja-JP" altLang="en-US" smtClean="0"/>
              <a:t>2025/2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46D73-5B25-4656-9AC0-ECFDA40330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17881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F94E3-3E99-4D87-8C79-4DA52A3888F2}" type="datetimeFigureOut">
              <a:rPr kumimoji="1" lang="ja-JP" altLang="en-US" smtClean="0"/>
              <a:t>2025/2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46D73-5B25-4656-9AC0-ECFDA40330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6036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F94E3-3E99-4D87-8C79-4DA52A3888F2}" type="datetimeFigureOut">
              <a:rPr kumimoji="1" lang="ja-JP" altLang="en-US" smtClean="0"/>
              <a:t>2025/2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46D73-5B25-4656-9AC0-ECFDA40330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11846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0405" y="768032"/>
            <a:ext cx="2624052" cy="2688114"/>
          </a:xfrm>
        </p:spPr>
        <p:txBody>
          <a:bodyPr anchor="b"/>
          <a:lstStyle>
            <a:lvl1pPr>
              <a:defRPr sz="284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458833" y="1658740"/>
            <a:ext cx="4118819" cy="8187013"/>
          </a:xfrm>
        </p:spPr>
        <p:txBody>
          <a:bodyPr/>
          <a:lstStyle>
            <a:lvl1pPr>
              <a:defRPr sz="2847"/>
            </a:lvl1pPr>
            <a:lvl2pPr>
              <a:defRPr sz="2491"/>
            </a:lvl2pPr>
            <a:lvl3pPr>
              <a:defRPr sz="2136"/>
            </a:lvl3pPr>
            <a:lvl4pPr>
              <a:defRPr sz="1780"/>
            </a:lvl4pPr>
            <a:lvl5pPr>
              <a:defRPr sz="1780"/>
            </a:lvl5pPr>
            <a:lvl6pPr>
              <a:defRPr sz="1780"/>
            </a:lvl6pPr>
            <a:lvl7pPr>
              <a:defRPr sz="1780"/>
            </a:lvl7pPr>
            <a:lvl8pPr>
              <a:defRPr sz="1780"/>
            </a:lvl8pPr>
            <a:lvl9pPr>
              <a:defRPr sz="178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0405" y="3456146"/>
            <a:ext cx="2624052" cy="6402939"/>
          </a:xfrm>
        </p:spPr>
        <p:txBody>
          <a:bodyPr/>
          <a:lstStyle>
            <a:lvl1pPr marL="0" indent="0">
              <a:buNone/>
              <a:defRPr sz="1424"/>
            </a:lvl1pPr>
            <a:lvl2pPr marL="406817" indent="0">
              <a:buNone/>
              <a:defRPr sz="1246"/>
            </a:lvl2pPr>
            <a:lvl3pPr marL="813633" indent="0">
              <a:buNone/>
              <a:defRPr sz="1068"/>
            </a:lvl3pPr>
            <a:lvl4pPr marL="1220450" indent="0">
              <a:buNone/>
              <a:defRPr sz="890"/>
            </a:lvl4pPr>
            <a:lvl5pPr marL="1627266" indent="0">
              <a:buNone/>
              <a:defRPr sz="890"/>
            </a:lvl5pPr>
            <a:lvl6pPr marL="2034083" indent="0">
              <a:buNone/>
              <a:defRPr sz="890"/>
            </a:lvl6pPr>
            <a:lvl7pPr marL="2440899" indent="0">
              <a:buNone/>
              <a:defRPr sz="890"/>
            </a:lvl7pPr>
            <a:lvl8pPr marL="2847716" indent="0">
              <a:buNone/>
              <a:defRPr sz="890"/>
            </a:lvl8pPr>
            <a:lvl9pPr marL="3254532" indent="0">
              <a:buNone/>
              <a:defRPr sz="89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F94E3-3E99-4D87-8C79-4DA52A3888F2}" type="datetimeFigureOut">
              <a:rPr kumimoji="1" lang="ja-JP" altLang="en-US" smtClean="0"/>
              <a:t>2025/2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46D73-5B25-4656-9AC0-ECFDA40330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67066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0405" y="768032"/>
            <a:ext cx="2624052" cy="2688114"/>
          </a:xfrm>
        </p:spPr>
        <p:txBody>
          <a:bodyPr anchor="b"/>
          <a:lstStyle>
            <a:lvl1pPr>
              <a:defRPr sz="284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458833" y="1658740"/>
            <a:ext cx="4118819" cy="8187013"/>
          </a:xfrm>
        </p:spPr>
        <p:txBody>
          <a:bodyPr anchor="t"/>
          <a:lstStyle>
            <a:lvl1pPr marL="0" indent="0">
              <a:buNone/>
              <a:defRPr sz="2847"/>
            </a:lvl1pPr>
            <a:lvl2pPr marL="406817" indent="0">
              <a:buNone/>
              <a:defRPr sz="2491"/>
            </a:lvl2pPr>
            <a:lvl3pPr marL="813633" indent="0">
              <a:buNone/>
              <a:defRPr sz="2136"/>
            </a:lvl3pPr>
            <a:lvl4pPr marL="1220450" indent="0">
              <a:buNone/>
              <a:defRPr sz="1780"/>
            </a:lvl4pPr>
            <a:lvl5pPr marL="1627266" indent="0">
              <a:buNone/>
              <a:defRPr sz="1780"/>
            </a:lvl5pPr>
            <a:lvl6pPr marL="2034083" indent="0">
              <a:buNone/>
              <a:defRPr sz="1780"/>
            </a:lvl6pPr>
            <a:lvl7pPr marL="2440899" indent="0">
              <a:buNone/>
              <a:defRPr sz="1780"/>
            </a:lvl7pPr>
            <a:lvl8pPr marL="2847716" indent="0">
              <a:buNone/>
              <a:defRPr sz="1780"/>
            </a:lvl8pPr>
            <a:lvl9pPr marL="3254532" indent="0">
              <a:buNone/>
              <a:defRPr sz="178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0405" y="3456146"/>
            <a:ext cx="2624052" cy="6402939"/>
          </a:xfrm>
        </p:spPr>
        <p:txBody>
          <a:bodyPr/>
          <a:lstStyle>
            <a:lvl1pPr marL="0" indent="0">
              <a:buNone/>
              <a:defRPr sz="1424"/>
            </a:lvl1pPr>
            <a:lvl2pPr marL="406817" indent="0">
              <a:buNone/>
              <a:defRPr sz="1246"/>
            </a:lvl2pPr>
            <a:lvl3pPr marL="813633" indent="0">
              <a:buNone/>
              <a:defRPr sz="1068"/>
            </a:lvl3pPr>
            <a:lvl4pPr marL="1220450" indent="0">
              <a:buNone/>
              <a:defRPr sz="890"/>
            </a:lvl4pPr>
            <a:lvl5pPr marL="1627266" indent="0">
              <a:buNone/>
              <a:defRPr sz="890"/>
            </a:lvl5pPr>
            <a:lvl6pPr marL="2034083" indent="0">
              <a:buNone/>
              <a:defRPr sz="890"/>
            </a:lvl6pPr>
            <a:lvl7pPr marL="2440899" indent="0">
              <a:buNone/>
              <a:defRPr sz="890"/>
            </a:lvl7pPr>
            <a:lvl8pPr marL="2847716" indent="0">
              <a:buNone/>
              <a:defRPr sz="890"/>
            </a:lvl8pPr>
            <a:lvl9pPr marL="3254532" indent="0">
              <a:buNone/>
              <a:defRPr sz="89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F94E3-3E99-4D87-8C79-4DA52A3888F2}" type="datetimeFigureOut">
              <a:rPr kumimoji="1" lang="ja-JP" altLang="en-US" smtClean="0"/>
              <a:t>2025/2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46D73-5B25-4656-9AC0-ECFDA40330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34972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59346" y="613362"/>
            <a:ext cx="7017247" cy="22267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59346" y="3066796"/>
            <a:ext cx="7017247" cy="73096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59346" y="10677788"/>
            <a:ext cx="1830586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6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EF94E3-3E99-4D87-8C79-4DA52A3888F2}" type="datetimeFigureOut">
              <a:rPr kumimoji="1" lang="ja-JP" altLang="en-US" smtClean="0"/>
              <a:t>2025/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95030" y="10677788"/>
            <a:ext cx="2745879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6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746006" y="10677788"/>
            <a:ext cx="1830586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6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846D73-5B25-4656-9AC0-ECFDA40330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42237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813633" rtl="0" eaLnBrk="1" latinLnBrk="0" hangingPunct="1">
        <a:lnSpc>
          <a:spcPct val="90000"/>
        </a:lnSpc>
        <a:spcBef>
          <a:spcPct val="0"/>
        </a:spcBef>
        <a:buNone/>
        <a:defRPr kumimoji="1" sz="391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3408" indent="-203408" algn="l" defTabSz="813633" rtl="0" eaLnBrk="1" latinLnBrk="0" hangingPunct="1">
        <a:lnSpc>
          <a:spcPct val="90000"/>
        </a:lnSpc>
        <a:spcBef>
          <a:spcPts val="890"/>
        </a:spcBef>
        <a:buFont typeface="Arial" panose="020B0604020202020204" pitchFamily="34" charset="0"/>
        <a:buChar char="•"/>
        <a:defRPr kumimoji="1" sz="2491" kern="1200">
          <a:solidFill>
            <a:schemeClr val="tx1"/>
          </a:solidFill>
          <a:latin typeface="+mn-lt"/>
          <a:ea typeface="+mn-ea"/>
          <a:cs typeface="+mn-cs"/>
        </a:defRPr>
      </a:lvl1pPr>
      <a:lvl2pPr marL="610225" indent="-203408" algn="l" defTabSz="813633" rtl="0" eaLnBrk="1" latinLnBrk="0" hangingPunct="1">
        <a:lnSpc>
          <a:spcPct val="90000"/>
        </a:lnSpc>
        <a:spcBef>
          <a:spcPts val="445"/>
        </a:spcBef>
        <a:buFont typeface="Arial" panose="020B0604020202020204" pitchFamily="34" charset="0"/>
        <a:buChar char="•"/>
        <a:defRPr kumimoji="1" sz="2136" kern="1200">
          <a:solidFill>
            <a:schemeClr val="tx1"/>
          </a:solidFill>
          <a:latin typeface="+mn-lt"/>
          <a:ea typeface="+mn-ea"/>
          <a:cs typeface="+mn-cs"/>
        </a:defRPr>
      </a:lvl2pPr>
      <a:lvl3pPr marL="1017041" indent="-203408" algn="l" defTabSz="813633" rtl="0" eaLnBrk="1" latinLnBrk="0" hangingPunct="1">
        <a:lnSpc>
          <a:spcPct val="90000"/>
        </a:lnSpc>
        <a:spcBef>
          <a:spcPts val="445"/>
        </a:spcBef>
        <a:buFont typeface="Arial" panose="020B0604020202020204" pitchFamily="34" charset="0"/>
        <a:buChar char="•"/>
        <a:defRPr kumimoji="1" sz="1780" kern="1200">
          <a:solidFill>
            <a:schemeClr val="tx1"/>
          </a:solidFill>
          <a:latin typeface="+mn-lt"/>
          <a:ea typeface="+mn-ea"/>
          <a:cs typeface="+mn-cs"/>
        </a:defRPr>
      </a:lvl3pPr>
      <a:lvl4pPr marL="1423858" indent="-203408" algn="l" defTabSz="813633" rtl="0" eaLnBrk="1" latinLnBrk="0" hangingPunct="1">
        <a:lnSpc>
          <a:spcPct val="90000"/>
        </a:lnSpc>
        <a:spcBef>
          <a:spcPts val="445"/>
        </a:spcBef>
        <a:buFont typeface="Arial" panose="020B0604020202020204" pitchFamily="34" charset="0"/>
        <a:buChar char="•"/>
        <a:defRPr kumimoji="1" sz="1602" kern="1200">
          <a:solidFill>
            <a:schemeClr val="tx1"/>
          </a:solidFill>
          <a:latin typeface="+mn-lt"/>
          <a:ea typeface="+mn-ea"/>
          <a:cs typeface="+mn-cs"/>
        </a:defRPr>
      </a:lvl4pPr>
      <a:lvl5pPr marL="1830675" indent="-203408" algn="l" defTabSz="813633" rtl="0" eaLnBrk="1" latinLnBrk="0" hangingPunct="1">
        <a:lnSpc>
          <a:spcPct val="90000"/>
        </a:lnSpc>
        <a:spcBef>
          <a:spcPts val="445"/>
        </a:spcBef>
        <a:buFont typeface="Arial" panose="020B0604020202020204" pitchFamily="34" charset="0"/>
        <a:buChar char="•"/>
        <a:defRPr kumimoji="1" sz="1602" kern="1200">
          <a:solidFill>
            <a:schemeClr val="tx1"/>
          </a:solidFill>
          <a:latin typeface="+mn-lt"/>
          <a:ea typeface="+mn-ea"/>
          <a:cs typeface="+mn-cs"/>
        </a:defRPr>
      </a:lvl5pPr>
      <a:lvl6pPr marL="2237491" indent="-203408" algn="l" defTabSz="813633" rtl="0" eaLnBrk="1" latinLnBrk="0" hangingPunct="1">
        <a:lnSpc>
          <a:spcPct val="90000"/>
        </a:lnSpc>
        <a:spcBef>
          <a:spcPts val="445"/>
        </a:spcBef>
        <a:buFont typeface="Arial" panose="020B0604020202020204" pitchFamily="34" charset="0"/>
        <a:buChar char="•"/>
        <a:defRPr kumimoji="1" sz="1602" kern="1200">
          <a:solidFill>
            <a:schemeClr val="tx1"/>
          </a:solidFill>
          <a:latin typeface="+mn-lt"/>
          <a:ea typeface="+mn-ea"/>
          <a:cs typeface="+mn-cs"/>
        </a:defRPr>
      </a:lvl6pPr>
      <a:lvl7pPr marL="2644308" indent="-203408" algn="l" defTabSz="813633" rtl="0" eaLnBrk="1" latinLnBrk="0" hangingPunct="1">
        <a:lnSpc>
          <a:spcPct val="90000"/>
        </a:lnSpc>
        <a:spcBef>
          <a:spcPts val="445"/>
        </a:spcBef>
        <a:buFont typeface="Arial" panose="020B0604020202020204" pitchFamily="34" charset="0"/>
        <a:buChar char="•"/>
        <a:defRPr kumimoji="1" sz="1602" kern="1200">
          <a:solidFill>
            <a:schemeClr val="tx1"/>
          </a:solidFill>
          <a:latin typeface="+mn-lt"/>
          <a:ea typeface="+mn-ea"/>
          <a:cs typeface="+mn-cs"/>
        </a:defRPr>
      </a:lvl7pPr>
      <a:lvl8pPr marL="3051124" indent="-203408" algn="l" defTabSz="813633" rtl="0" eaLnBrk="1" latinLnBrk="0" hangingPunct="1">
        <a:lnSpc>
          <a:spcPct val="90000"/>
        </a:lnSpc>
        <a:spcBef>
          <a:spcPts val="445"/>
        </a:spcBef>
        <a:buFont typeface="Arial" panose="020B0604020202020204" pitchFamily="34" charset="0"/>
        <a:buChar char="•"/>
        <a:defRPr kumimoji="1" sz="1602" kern="1200">
          <a:solidFill>
            <a:schemeClr val="tx1"/>
          </a:solidFill>
          <a:latin typeface="+mn-lt"/>
          <a:ea typeface="+mn-ea"/>
          <a:cs typeface="+mn-cs"/>
        </a:defRPr>
      </a:lvl8pPr>
      <a:lvl9pPr marL="3457941" indent="-203408" algn="l" defTabSz="813633" rtl="0" eaLnBrk="1" latinLnBrk="0" hangingPunct="1">
        <a:lnSpc>
          <a:spcPct val="90000"/>
        </a:lnSpc>
        <a:spcBef>
          <a:spcPts val="445"/>
        </a:spcBef>
        <a:buFont typeface="Arial" panose="020B0604020202020204" pitchFamily="34" charset="0"/>
        <a:buChar char="•"/>
        <a:defRPr kumimoji="1" sz="160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13633" rtl="0" eaLnBrk="1" latinLnBrk="0" hangingPunct="1">
        <a:defRPr kumimoji="1" sz="1602" kern="1200">
          <a:solidFill>
            <a:schemeClr val="tx1"/>
          </a:solidFill>
          <a:latin typeface="+mn-lt"/>
          <a:ea typeface="+mn-ea"/>
          <a:cs typeface="+mn-cs"/>
        </a:defRPr>
      </a:lvl1pPr>
      <a:lvl2pPr marL="406817" algn="l" defTabSz="813633" rtl="0" eaLnBrk="1" latinLnBrk="0" hangingPunct="1">
        <a:defRPr kumimoji="1" sz="1602" kern="1200">
          <a:solidFill>
            <a:schemeClr val="tx1"/>
          </a:solidFill>
          <a:latin typeface="+mn-lt"/>
          <a:ea typeface="+mn-ea"/>
          <a:cs typeface="+mn-cs"/>
        </a:defRPr>
      </a:lvl2pPr>
      <a:lvl3pPr marL="813633" algn="l" defTabSz="813633" rtl="0" eaLnBrk="1" latinLnBrk="0" hangingPunct="1">
        <a:defRPr kumimoji="1" sz="1602" kern="1200">
          <a:solidFill>
            <a:schemeClr val="tx1"/>
          </a:solidFill>
          <a:latin typeface="+mn-lt"/>
          <a:ea typeface="+mn-ea"/>
          <a:cs typeface="+mn-cs"/>
        </a:defRPr>
      </a:lvl3pPr>
      <a:lvl4pPr marL="1220450" algn="l" defTabSz="813633" rtl="0" eaLnBrk="1" latinLnBrk="0" hangingPunct="1">
        <a:defRPr kumimoji="1" sz="1602" kern="1200">
          <a:solidFill>
            <a:schemeClr val="tx1"/>
          </a:solidFill>
          <a:latin typeface="+mn-lt"/>
          <a:ea typeface="+mn-ea"/>
          <a:cs typeface="+mn-cs"/>
        </a:defRPr>
      </a:lvl4pPr>
      <a:lvl5pPr marL="1627266" algn="l" defTabSz="813633" rtl="0" eaLnBrk="1" latinLnBrk="0" hangingPunct="1">
        <a:defRPr kumimoji="1" sz="1602" kern="1200">
          <a:solidFill>
            <a:schemeClr val="tx1"/>
          </a:solidFill>
          <a:latin typeface="+mn-lt"/>
          <a:ea typeface="+mn-ea"/>
          <a:cs typeface="+mn-cs"/>
        </a:defRPr>
      </a:lvl5pPr>
      <a:lvl6pPr marL="2034083" algn="l" defTabSz="813633" rtl="0" eaLnBrk="1" latinLnBrk="0" hangingPunct="1">
        <a:defRPr kumimoji="1" sz="1602" kern="1200">
          <a:solidFill>
            <a:schemeClr val="tx1"/>
          </a:solidFill>
          <a:latin typeface="+mn-lt"/>
          <a:ea typeface="+mn-ea"/>
          <a:cs typeface="+mn-cs"/>
        </a:defRPr>
      </a:lvl6pPr>
      <a:lvl7pPr marL="2440899" algn="l" defTabSz="813633" rtl="0" eaLnBrk="1" latinLnBrk="0" hangingPunct="1">
        <a:defRPr kumimoji="1" sz="1602" kern="1200">
          <a:solidFill>
            <a:schemeClr val="tx1"/>
          </a:solidFill>
          <a:latin typeface="+mn-lt"/>
          <a:ea typeface="+mn-ea"/>
          <a:cs typeface="+mn-cs"/>
        </a:defRPr>
      </a:lvl7pPr>
      <a:lvl8pPr marL="2847716" algn="l" defTabSz="813633" rtl="0" eaLnBrk="1" latinLnBrk="0" hangingPunct="1">
        <a:defRPr kumimoji="1" sz="1602" kern="1200">
          <a:solidFill>
            <a:schemeClr val="tx1"/>
          </a:solidFill>
          <a:latin typeface="+mn-lt"/>
          <a:ea typeface="+mn-ea"/>
          <a:cs typeface="+mn-cs"/>
        </a:defRPr>
      </a:lvl8pPr>
      <a:lvl9pPr marL="3254532" algn="l" defTabSz="813633" rtl="0" eaLnBrk="1" latinLnBrk="0" hangingPunct="1">
        <a:defRPr kumimoji="1" sz="160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" name="図 80">
            <a:extLst>
              <a:ext uri="{FF2B5EF4-FFF2-40B4-BE49-F238E27FC236}">
                <a16:creationId xmlns:a16="http://schemas.microsoft.com/office/drawing/2014/main" id="{A27DA01C-7F0E-F437-2978-7ADE9E3948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65974" y="5777956"/>
            <a:ext cx="3661334" cy="2380816"/>
          </a:xfrm>
          <a:prstGeom prst="rect">
            <a:avLst/>
          </a:prstGeom>
        </p:spPr>
      </p:pic>
      <p:pic>
        <p:nvPicPr>
          <p:cNvPr id="52" name="図 51">
            <a:extLst>
              <a:ext uri="{FF2B5EF4-FFF2-40B4-BE49-F238E27FC236}">
                <a16:creationId xmlns:a16="http://schemas.microsoft.com/office/drawing/2014/main" id="{FA39CF53-E9F1-4D74-8F8F-BBD904B8A60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4393" y="5782173"/>
            <a:ext cx="3812205" cy="2478921"/>
          </a:xfrm>
          <a:prstGeom prst="rect">
            <a:avLst/>
          </a:prstGeom>
        </p:spPr>
      </p:pic>
      <p:pic>
        <p:nvPicPr>
          <p:cNvPr id="48" name="図 47">
            <a:extLst>
              <a:ext uri="{FF2B5EF4-FFF2-40B4-BE49-F238E27FC236}">
                <a16:creationId xmlns:a16="http://schemas.microsoft.com/office/drawing/2014/main" id="{AFF15E32-7336-09B5-C65B-52DE89860FE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06592" y="832928"/>
            <a:ext cx="3325417" cy="2050810"/>
          </a:xfrm>
          <a:prstGeom prst="rect">
            <a:avLst/>
          </a:prstGeom>
        </p:spPr>
      </p:pic>
      <p:pic>
        <p:nvPicPr>
          <p:cNvPr id="45" name="図 44">
            <a:extLst>
              <a:ext uri="{FF2B5EF4-FFF2-40B4-BE49-F238E27FC236}">
                <a16:creationId xmlns:a16="http://schemas.microsoft.com/office/drawing/2014/main" id="{2C14CC59-3281-6C6A-4234-9EB57844C3E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2525" y="850788"/>
            <a:ext cx="3325419" cy="2050811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DAB3AE6-8638-9C8D-2A71-DB73C2C5F4DB}"/>
              </a:ext>
            </a:extLst>
          </p:cNvPr>
          <p:cNvSpPr txBox="1"/>
          <p:nvPr/>
        </p:nvSpPr>
        <p:spPr>
          <a:xfrm>
            <a:off x="48069" y="261930"/>
            <a:ext cx="3069282" cy="3745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801" b="1" dirty="0"/>
              <a:t>Supplemental </a:t>
            </a:r>
            <a:r>
              <a:rPr kumimoji="1" lang="en-US" altLang="ja-JP" sz="1801" b="1"/>
              <a:t>Figure 1</a:t>
            </a:r>
            <a:endParaRPr kumimoji="1" lang="ja-JP" altLang="en-US" sz="1801" b="1" dirty="0"/>
          </a:p>
        </p:txBody>
      </p:sp>
      <p:sp>
        <p:nvSpPr>
          <p:cNvPr id="179" name="テキスト ボックス 178">
            <a:extLst>
              <a:ext uri="{FF2B5EF4-FFF2-40B4-BE49-F238E27FC236}">
                <a16:creationId xmlns:a16="http://schemas.microsoft.com/office/drawing/2014/main" id="{5AD30BFC-0E87-17B8-ED86-333BA1910762}"/>
              </a:ext>
            </a:extLst>
          </p:cNvPr>
          <p:cNvSpPr txBox="1"/>
          <p:nvPr/>
        </p:nvSpPr>
        <p:spPr>
          <a:xfrm>
            <a:off x="190475" y="696966"/>
            <a:ext cx="5115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F7AADF1-0F11-C1AE-4A8C-8A0682C77721}"/>
              </a:ext>
            </a:extLst>
          </p:cNvPr>
          <p:cNvSpPr txBox="1"/>
          <p:nvPr/>
        </p:nvSpPr>
        <p:spPr>
          <a:xfrm>
            <a:off x="2621576" y="1413274"/>
            <a:ext cx="15207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ystematic therapy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E79A1E2-EA28-E007-8C2D-0E5EE486739E}"/>
              </a:ext>
            </a:extLst>
          </p:cNvPr>
          <p:cNvSpPr txBox="1"/>
          <p:nvPr/>
        </p:nvSpPr>
        <p:spPr>
          <a:xfrm>
            <a:off x="2641682" y="1125669"/>
            <a:ext cx="7480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AT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243CA450-D1A8-740E-417B-7852376E6B9E}"/>
              </a:ext>
            </a:extLst>
          </p:cNvPr>
          <p:cNvCxnSpPr>
            <a:cxnSpLocks/>
          </p:cNvCxnSpPr>
          <p:nvPr/>
        </p:nvCxnSpPr>
        <p:spPr>
          <a:xfrm>
            <a:off x="2242469" y="1267746"/>
            <a:ext cx="377607" cy="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7AC3A75A-6463-91C8-AC3F-0EFD427C1D21}"/>
              </a:ext>
            </a:extLst>
          </p:cNvPr>
          <p:cNvCxnSpPr>
            <a:cxnSpLocks/>
          </p:cNvCxnSpPr>
          <p:nvPr/>
        </p:nvCxnSpPr>
        <p:spPr>
          <a:xfrm>
            <a:off x="2242810" y="1550110"/>
            <a:ext cx="377607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E542BB6C-12D4-14C9-0D36-14AB1ACB4B7B}"/>
              </a:ext>
            </a:extLst>
          </p:cNvPr>
          <p:cNvSpPr txBox="1"/>
          <p:nvPr/>
        </p:nvSpPr>
        <p:spPr>
          <a:xfrm>
            <a:off x="1360604" y="3067148"/>
            <a:ext cx="5445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067059D-700D-AA51-9F9C-FE366E34D755}"/>
              </a:ext>
            </a:extLst>
          </p:cNvPr>
          <p:cNvSpPr txBox="1"/>
          <p:nvPr/>
        </p:nvSpPr>
        <p:spPr>
          <a:xfrm>
            <a:off x="1359395" y="3415243"/>
            <a:ext cx="4083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3533D27C-3D68-B294-565A-86CA18FB76E4}"/>
              </a:ext>
            </a:extLst>
          </p:cNvPr>
          <p:cNvSpPr txBox="1"/>
          <p:nvPr/>
        </p:nvSpPr>
        <p:spPr>
          <a:xfrm>
            <a:off x="1964923" y="3067148"/>
            <a:ext cx="5715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4812C43-A853-AD61-8C46-7DC121C2BD9E}"/>
              </a:ext>
            </a:extLst>
          </p:cNvPr>
          <p:cNvSpPr txBox="1"/>
          <p:nvPr/>
        </p:nvSpPr>
        <p:spPr>
          <a:xfrm>
            <a:off x="2524071" y="3067147"/>
            <a:ext cx="2884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D8E6924-C855-FF9E-9F19-2B1668247E34}"/>
              </a:ext>
            </a:extLst>
          </p:cNvPr>
          <p:cNvSpPr txBox="1"/>
          <p:nvPr/>
        </p:nvSpPr>
        <p:spPr>
          <a:xfrm>
            <a:off x="3087045" y="3067147"/>
            <a:ext cx="2884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0F412DE-9B3B-B88C-509F-6E97CEB61B61}"/>
              </a:ext>
            </a:extLst>
          </p:cNvPr>
          <p:cNvSpPr txBox="1"/>
          <p:nvPr/>
        </p:nvSpPr>
        <p:spPr>
          <a:xfrm>
            <a:off x="3612984" y="3058834"/>
            <a:ext cx="2884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75340785-FAD4-E3BF-9930-1B8E4C1B311A}"/>
              </a:ext>
            </a:extLst>
          </p:cNvPr>
          <p:cNvSpPr txBox="1"/>
          <p:nvPr/>
        </p:nvSpPr>
        <p:spPr>
          <a:xfrm>
            <a:off x="1962665" y="3415244"/>
            <a:ext cx="3809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00805FA-928E-205E-663B-DCB8BFA54042}"/>
              </a:ext>
            </a:extLst>
          </p:cNvPr>
          <p:cNvSpPr txBox="1"/>
          <p:nvPr/>
        </p:nvSpPr>
        <p:spPr>
          <a:xfrm>
            <a:off x="2534842" y="3415244"/>
            <a:ext cx="4498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56C76B29-5FE7-BDDD-140D-7E7A9DD9C4E1}"/>
              </a:ext>
            </a:extLst>
          </p:cNvPr>
          <p:cNvSpPr txBox="1"/>
          <p:nvPr/>
        </p:nvSpPr>
        <p:spPr>
          <a:xfrm>
            <a:off x="3085088" y="3415244"/>
            <a:ext cx="4544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EF194DC-1052-C386-18D8-13A368617B96}"/>
              </a:ext>
            </a:extLst>
          </p:cNvPr>
          <p:cNvSpPr txBox="1"/>
          <p:nvPr/>
        </p:nvSpPr>
        <p:spPr>
          <a:xfrm>
            <a:off x="3612984" y="3415243"/>
            <a:ext cx="3597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5EF8750-B237-5E09-5A94-5AB89D4CD04E}"/>
              </a:ext>
            </a:extLst>
          </p:cNvPr>
          <p:cNvSpPr txBox="1"/>
          <p:nvPr/>
        </p:nvSpPr>
        <p:spPr>
          <a:xfrm>
            <a:off x="76321" y="2770799"/>
            <a:ext cx="15207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  <a:endParaRPr lang="ja-JP" altLang="en-US" sz="11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7EFB9282-6448-8C11-FF3A-30D09D785124}"/>
              </a:ext>
            </a:extLst>
          </p:cNvPr>
          <p:cNvSpPr txBox="1"/>
          <p:nvPr/>
        </p:nvSpPr>
        <p:spPr>
          <a:xfrm>
            <a:off x="883061" y="3066362"/>
            <a:ext cx="5985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LAT</a:t>
            </a:r>
            <a:endParaRPr lang="ja-JP" altLang="en-US" sz="11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BF578F07-6296-CF7C-CFDE-7E73397A0106}"/>
              </a:ext>
            </a:extLst>
          </p:cNvPr>
          <p:cNvSpPr txBox="1"/>
          <p:nvPr/>
        </p:nvSpPr>
        <p:spPr>
          <a:xfrm>
            <a:off x="5288550" y="3067148"/>
            <a:ext cx="5445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198D645D-EEA1-A6B4-2DD8-FA9840BE74BC}"/>
              </a:ext>
            </a:extLst>
          </p:cNvPr>
          <p:cNvSpPr txBox="1"/>
          <p:nvPr/>
        </p:nvSpPr>
        <p:spPr>
          <a:xfrm>
            <a:off x="5287340" y="3415243"/>
            <a:ext cx="4083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14E7268A-B020-87F7-1EF2-2F179C18778D}"/>
              </a:ext>
            </a:extLst>
          </p:cNvPr>
          <p:cNvSpPr txBox="1"/>
          <p:nvPr/>
        </p:nvSpPr>
        <p:spPr>
          <a:xfrm>
            <a:off x="5861110" y="3067148"/>
            <a:ext cx="5715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D0AF1AB6-6FF9-DDAE-1AB8-E7D4D9A8A0D5}"/>
              </a:ext>
            </a:extLst>
          </p:cNvPr>
          <p:cNvSpPr txBox="1"/>
          <p:nvPr/>
        </p:nvSpPr>
        <p:spPr>
          <a:xfrm>
            <a:off x="6404305" y="3067147"/>
            <a:ext cx="2884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76859A33-CE09-A50B-BF2D-BF5E6726F797}"/>
              </a:ext>
            </a:extLst>
          </p:cNvPr>
          <p:cNvSpPr txBox="1"/>
          <p:nvPr/>
        </p:nvSpPr>
        <p:spPr>
          <a:xfrm>
            <a:off x="6948727" y="3067147"/>
            <a:ext cx="2884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4EA7CDDE-EA66-4400-E155-3FADB568C08D}"/>
              </a:ext>
            </a:extLst>
          </p:cNvPr>
          <p:cNvSpPr txBox="1"/>
          <p:nvPr/>
        </p:nvSpPr>
        <p:spPr>
          <a:xfrm>
            <a:off x="7506538" y="3058834"/>
            <a:ext cx="2884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EF726792-6EED-6347-A311-FF6ABD8566B3}"/>
              </a:ext>
            </a:extLst>
          </p:cNvPr>
          <p:cNvSpPr txBox="1"/>
          <p:nvPr/>
        </p:nvSpPr>
        <p:spPr>
          <a:xfrm>
            <a:off x="5865032" y="3415244"/>
            <a:ext cx="4083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0B774B3B-B16C-7A9E-20C5-E925D1EEA160}"/>
              </a:ext>
            </a:extLst>
          </p:cNvPr>
          <p:cNvSpPr txBox="1"/>
          <p:nvPr/>
        </p:nvSpPr>
        <p:spPr>
          <a:xfrm>
            <a:off x="6407125" y="3415244"/>
            <a:ext cx="4498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91B0F222-C348-AEA5-7B25-690FD3F0214A}"/>
              </a:ext>
            </a:extLst>
          </p:cNvPr>
          <p:cNvSpPr txBox="1"/>
          <p:nvPr/>
        </p:nvSpPr>
        <p:spPr>
          <a:xfrm>
            <a:off x="6955585" y="3415244"/>
            <a:ext cx="4544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8BB44A87-344F-3585-4D9F-3BE9EE7E0C66}"/>
              </a:ext>
            </a:extLst>
          </p:cNvPr>
          <p:cNvSpPr txBox="1"/>
          <p:nvPr/>
        </p:nvSpPr>
        <p:spPr>
          <a:xfrm>
            <a:off x="7501236" y="3415243"/>
            <a:ext cx="3597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735B6E22-CAE7-CF82-29E2-EB6B539DAB08}"/>
              </a:ext>
            </a:extLst>
          </p:cNvPr>
          <p:cNvSpPr txBox="1"/>
          <p:nvPr/>
        </p:nvSpPr>
        <p:spPr>
          <a:xfrm>
            <a:off x="4044952" y="2770799"/>
            <a:ext cx="15207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  <a:endParaRPr lang="ja-JP" altLang="en-US" sz="11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D67AC0ED-23A1-5306-2ED1-A099DD255C2E}"/>
              </a:ext>
            </a:extLst>
          </p:cNvPr>
          <p:cNvSpPr txBox="1"/>
          <p:nvPr/>
        </p:nvSpPr>
        <p:spPr>
          <a:xfrm>
            <a:off x="14583" y="3409041"/>
            <a:ext cx="13970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Systemic therapy</a:t>
            </a:r>
            <a:endParaRPr lang="ja-JP" altLang="en-US" sz="11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62FF4E4D-8C0C-1DDD-DCE3-A7DA641EA82C}"/>
              </a:ext>
            </a:extLst>
          </p:cNvPr>
          <p:cNvSpPr txBox="1"/>
          <p:nvPr/>
        </p:nvSpPr>
        <p:spPr>
          <a:xfrm>
            <a:off x="1269661" y="3655999"/>
            <a:ext cx="18476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u="sng" dirty="0">
                <a:latin typeface="Arial" panose="020B0604020202020204" pitchFamily="34" charset="0"/>
                <a:cs typeface="Arial" panose="020B0604020202020204" pitchFamily="34" charset="0"/>
              </a:rPr>
              <a:t>PFS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4E207C80-1F08-E516-A7BA-115FA388E70C}"/>
              </a:ext>
            </a:extLst>
          </p:cNvPr>
          <p:cNvSpPr txBox="1"/>
          <p:nvPr/>
        </p:nvSpPr>
        <p:spPr>
          <a:xfrm>
            <a:off x="4401077" y="3656002"/>
            <a:ext cx="37729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u="sng" dirty="0">
                <a:latin typeface="Arial" panose="020B0604020202020204" pitchFamily="34" charset="0"/>
                <a:cs typeface="Arial" panose="020B0604020202020204" pitchFamily="34" charset="0"/>
              </a:rPr>
              <a:t>LPFS</a:t>
            </a:r>
            <a:endParaRPr kumimoji="1"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3453CABF-58E1-718C-42A5-1C345EEEE3DA}"/>
              </a:ext>
            </a:extLst>
          </p:cNvPr>
          <p:cNvSpPr txBox="1"/>
          <p:nvPr/>
        </p:nvSpPr>
        <p:spPr>
          <a:xfrm>
            <a:off x="4013734" y="690341"/>
            <a:ext cx="5115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65026735-E59E-DC7A-7F99-938F10496544}"/>
              </a:ext>
            </a:extLst>
          </p:cNvPr>
          <p:cNvSpPr txBox="1"/>
          <p:nvPr/>
        </p:nvSpPr>
        <p:spPr>
          <a:xfrm>
            <a:off x="1306279" y="8090097"/>
            <a:ext cx="5445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D3C03BE7-2D44-6EE0-C50F-9BA75138EFE4}"/>
              </a:ext>
            </a:extLst>
          </p:cNvPr>
          <p:cNvSpPr txBox="1"/>
          <p:nvPr/>
        </p:nvSpPr>
        <p:spPr>
          <a:xfrm>
            <a:off x="1807353" y="8090096"/>
            <a:ext cx="281884" cy="2690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D27DB2E1-04ED-49BD-8B83-635D3759159D}"/>
              </a:ext>
            </a:extLst>
          </p:cNvPr>
          <p:cNvSpPr txBox="1"/>
          <p:nvPr/>
        </p:nvSpPr>
        <p:spPr>
          <a:xfrm>
            <a:off x="2295868" y="8090096"/>
            <a:ext cx="404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55827A4D-47FB-DF6A-C92F-53B08EE0B9C2}"/>
              </a:ext>
            </a:extLst>
          </p:cNvPr>
          <p:cNvSpPr txBox="1"/>
          <p:nvPr/>
        </p:nvSpPr>
        <p:spPr>
          <a:xfrm>
            <a:off x="3254571" y="8082145"/>
            <a:ext cx="2884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1A873007-C73B-334D-A251-FC944FE32441}"/>
              </a:ext>
            </a:extLst>
          </p:cNvPr>
          <p:cNvSpPr txBox="1"/>
          <p:nvPr/>
        </p:nvSpPr>
        <p:spPr>
          <a:xfrm>
            <a:off x="3721325" y="8081783"/>
            <a:ext cx="2884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18DEE868-3704-8C68-094B-F7E442C7B74F}"/>
              </a:ext>
            </a:extLst>
          </p:cNvPr>
          <p:cNvSpPr txBox="1"/>
          <p:nvPr/>
        </p:nvSpPr>
        <p:spPr>
          <a:xfrm>
            <a:off x="65452" y="7793748"/>
            <a:ext cx="15207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  <a:endParaRPr lang="ja-JP" altLang="en-US" sz="11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C5532557-4143-5102-FC32-55A77ECDC4E7}"/>
              </a:ext>
            </a:extLst>
          </p:cNvPr>
          <p:cNvSpPr txBox="1"/>
          <p:nvPr/>
        </p:nvSpPr>
        <p:spPr>
          <a:xfrm>
            <a:off x="4119383" y="7793748"/>
            <a:ext cx="15207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  <a:endParaRPr lang="ja-JP" altLang="en-US" sz="11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046189D9-4F38-7386-8FBA-8B0CB44F29D0}"/>
              </a:ext>
            </a:extLst>
          </p:cNvPr>
          <p:cNvSpPr txBox="1"/>
          <p:nvPr/>
        </p:nvSpPr>
        <p:spPr>
          <a:xfrm>
            <a:off x="2793210" y="8090436"/>
            <a:ext cx="404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F2C28285-98EF-8D58-33CC-06EB970D5123}"/>
              </a:ext>
            </a:extLst>
          </p:cNvPr>
          <p:cNvSpPr txBox="1"/>
          <p:nvPr/>
        </p:nvSpPr>
        <p:spPr>
          <a:xfrm>
            <a:off x="1300516" y="8441282"/>
            <a:ext cx="5445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0E4415D7-FDAA-0CAA-9D2E-B5FEF4EA97AD}"/>
              </a:ext>
            </a:extLst>
          </p:cNvPr>
          <p:cNvSpPr txBox="1"/>
          <p:nvPr/>
        </p:nvSpPr>
        <p:spPr>
          <a:xfrm>
            <a:off x="1771469" y="8441282"/>
            <a:ext cx="5715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6A6A6B6C-26B1-4E9E-78C6-D5CF815CCA64}"/>
              </a:ext>
            </a:extLst>
          </p:cNvPr>
          <p:cNvSpPr txBox="1"/>
          <p:nvPr/>
        </p:nvSpPr>
        <p:spPr>
          <a:xfrm>
            <a:off x="2261753" y="8441281"/>
            <a:ext cx="404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56B96D6F-3322-8357-33C4-03E14E66545D}"/>
              </a:ext>
            </a:extLst>
          </p:cNvPr>
          <p:cNvSpPr txBox="1"/>
          <p:nvPr/>
        </p:nvSpPr>
        <p:spPr>
          <a:xfrm>
            <a:off x="3261213" y="8433330"/>
            <a:ext cx="2884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FBE55F7E-A55B-58FC-7EAF-3CEF1E423E5F}"/>
              </a:ext>
            </a:extLst>
          </p:cNvPr>
          <p:cNvSpPr txBox="1"/>
          <p:nvPr/>
        </p:nvSpPr>
        <p:spPr>
          <a:xfrm>
            <a:off x="3724423" y="8432968"/>
            <a:ext cx="2884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64A13544-CF40-1215-F6B1-B7833FF0EB3E}"/>
              </a:ext>
            </a:extLst>
          </p:cNvPr>
          <p:cNvSpPr txBox="1"/>
          <p:nvPr/>
        </p:nvSpPr>
        <p:spPr>
          <a:xfrm>
            <a:off x="2757619" y="8440758"/>
            <a:ext cx="404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C79933B1-1A03-43A4-C486-27C5E5A08320}"/>
              </a:ext>
            </a:extLst>
          </p:cNvPr>
          <p:cNvSpPr txBox="1"/>
          <p:nvPr/>
        </p:nvSpPr>
        <p:spPr>
          <a:xfrm>
            <a:off x="5273300" y="8442609"/>
            <a:ext cx="5445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6BCC4C75-E11D-13E0-A504-63E9DD37852C}"/>
              </a:ext>
            </a:extLst>
          </p:cNvPr>
          <p:cNvSpPr txBox="1"/>
          <p:nvPr/>
        </p:nvSpPr>
        <p:spPr>
          <a:xfrm>
            <a:off x="5709944" y="8442609"/>
            <a:ext cx="5715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DDF65586-60E2-B5AE-81A5-2816A819305A}"/>
              </a:ext>
            </a:extLst>
          </p:cNvPr>
          <p:cNvSpPr txBox="1"/>
          <p:nvPr/>
        </p:nvSpPr>
        <p:spPr>
          <a:xfrm>
            <a:off x="6193617" y="8442608"/>
            <a:ext cx="404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5904588E-725F-5738-7AA6-442B13A4F5A6}"/>
              </a:ext>
            </a:extLst>
          </p:cNvPr>
          <p:cNvSpPr txBox="1"/>
          <p:nvPr/>
        </p:nvSpPr>
        <p:spPr>
          <a:xfrm>
            <a:off x="7121658" y="8442608"/>
            <a:ext cx="2884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53BEF817-C73A-400C-AADF-B200DB4885D7}"/>
              </a:ext>
            </a:extLst>
          </p:cNvPr>
          <p:cNvSpPr txBox="1"/>
          <p:nvPr/>
        </p:nvSpPr>
        <p:spPr>
          <a:xfrm>
            <a:off x="7591940" y="8450197"/>
            <a:ext cx="2884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E37C4399-9C5C-13CE-3B02-1330B9A56426}"/>
              </a:ext>
            </a:extLst>
          </p:cNvPr>
          <p:cNvSpPr txBox="1"/>
          <p:nvPr/>
        </p:nvSpPr>
        <p:spPr>
          <a:xfrm>
            <a:off x="6646937" y="8442085"/>
            <a:ext cx="404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CF351350-64F3-4206-194B-FA79749ED9EC}"/>
              </a:ext>
            </a:extLst>
          </p:cNvPr>
          <p:cNvSpPr txBox="1"/>
          <p:nvPr/>
        </p:nvSpPr>
        <p:spPr>
          <a:xfrm>
            <a:off x="5271978" y="8091423"/>
            <a:ext cx="5445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E77EE8E0-9F7C-C2B2-A9F9-931566886457}"/>
              </a:ext>
            </a:extLst>
          </p:cNvPr>
          <p:cNvSpPr txBox="1"/>
          <p:nvPr/>
        </p:nvSpPr>
        <p:spPr>
          <a:xfrm>
            <a:off x="5737837" y="8091423"/>
            <a:ext cx="2508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19754358-BAC8-3462-5BF8-D5EAFCD30509}"/>
              </a:ext>
            </a:extLst>
          </p:cNvPr>
          <p:cNvSpPr txBox="1"/>
          <p:nvPr/>
        </p:nvSpPr>
        <p:spPr>
          <a:xfrm>
            <a:off x="6191605" y="8091422"/>
            <a:ext cx="404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CF7D5EDE-C988-1A42-4585-AB2BB4A67A36}"/>
              </a:ext>
            </a:extLst>
          </p:cNvPr>
          <p:cNvSpPr txBox="1"/>
          <p:nvPr/>
        </p:nvSpPr>
        <p:spPr>
          <a:xfrm>
            <a:off x="7120336" y="8083471"/>
            <a:ext cx="2884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6AF6E577-ACB6-31BB-5C0D-487699B8B9A8}"/>
              </a:ext>
            </a:extLst>
          </p:cNvPr>
          <p:cNvSpPr txBox="1"/>
          <p:nvPr/>
        </p:nvSpPr>
        <p:spPr>
          <a:xfrm>
            <a:off x="7584393" y="8083109"/>
            <a:ext cx="2884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0DA24F76-7191-EC84-49E6-4912FB1EBCC5}"/>
              </a:ext>
            </a:extLst>
          </p:cNvPr>
          <p:cNvSpPr txBox="1"/>
          <p:nvPr/>
        </p:nvSpPr>
        <p:spPr>
          <a:xfrm>
            <a:off x="6645615" y="8090899"/>
            <a:ext cx="404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963E259D-5DCD-4F73-6B3D-D98780E6C19A}"/>
              </a:ext>
            </a:extLst>
          </p:cNvPr>
          <p:cNvSpPr txBox="1"/>
          <p:nvPr/>
        </p:nvSpPr>
        <p:spPr>
          <a:xfrm>
            <a:off x="1263036" y="8695453"/>
            <a:ext cx="18476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u="sng" dirty="0">
                <a:latin typeface="Arial" panose="020B0604020202020204" pitchFamily="34" charset="0"/>
                <a:cs typeface="Arial" panose="020B0604020202020204" pitchFamily="34" charset="0"/>
              </a:rPr>
              <a:t>OS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F3700C33-AA60-E042-B8AE-D1011673C461}"/>
              </a:ext>
            </a:extLst>
          </p:cNvPr>
          <p:cNvSpPr txBox="1"/>
          <p:nvPr/>
        </p:nvSpPr>
        <p:spPr>
          <a:xfrm>
            <a:off x="4394452" y="8695456"/>
            <a:ext cx="37729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u="sng" dirty="0">
                <a:latin typeface="Arial" panose="020B0604020202020204" pitchFamily="34" charset="0"/>
                <a:cs typeface="Arial" panose="020B0604020202020204" pitchFamily="34" charset="0"/>
              </a:rPr>
              <a:t>OP-OS</a:t>
            </a:r>
            <a:endParaRPr kumimoji="1"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1DB903FA-64E4-5D6F-A463-83928ED09C71}"/>
              </a:ext>
            </a:extLst>
          </p:cNvPr>
          <p:cNvSpPr txBox="1"/>
          <p:nvPr/>
        </p:nvSpPr>
        <p:spPr>
          <a:xfrm>
            <a:off x="183851" y="5553900"/>
            <a:ext cx="5115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F97903B8-CF8B-353F-4664-0A61B47A9BE6}"/>
              </a:ext>
            </a:extLst>
          </p:cNvPr>
          <p:cNvSpPr txBox="1"/>
          <p:nvPr/>
        </p:nvSpPr>
        <p:spPr>
          <a:xfrm>
            <a:off x="4007110" y="5547275"/>
            <a:ext cx="5115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62789E6F-EB6B-CC6C-0C0D-E7E199D3E9BA}"/>
              </a:ext>
            </a:extLst>
          </p:cNvPr>
          <p:cNvSpPr txBox="1"/>
          <p:nvPr/>
        </p:nvSpPr>
        <p:spPr>
          <a:xfrm>
            <a:off x="6488290" y="1416821"/>
            <a:ext cx="15207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ystematic therapy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3BDFF157-C8D1-889E-1BCE-092123C41686}"/>
              </a:ext>
            </a:extLst>
          </p:cNvPr>
          <p:cNvSpPr txBox="1"/>
          <p:nvPr/>
        </p:nvSpPr>
        <p:spPr>
          <a:xfrm>
            <a:off x="6508396" y="1129216"/>
            <a:ext cx="7480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AT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6" name="直線コネクタ 105">
            <a:extLst>
              <a:ext uri="{FF2B5EF4-FFF2-40B4-BE49-F238E27FC236}">
                <a16:creationId xmlns:a16="http://schemas.microsoft.com/office/drawing/2014/main" id="{44EF8290-3412-8174-0663-6511FD94B5C7}"/>
              </a:ext>
            </a:extLst>
          </p:cNvPr>
          <p:cNvCxnSpPr>
            <a:cxnSpLocks/>
          </p:cNvCxnSpPr>
          <p:nvPr/>
        </p:nvCxnSpPr>
        <p:spPr>
          <a:xfrm>
            <a:off x="6109183" y="1271293"/>
            <a:ext cx="377607" cy="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直線コネクタ 106">
            <a:extLst>
              <a:ext uri="{FF2B5EF4-FFF2-40B4-BE49-F238E27FC236}">
                <a16:creationId xmlns:a16="http://schemas.microsoft.com/office/drawing/2014/main" id="{266E36B5-90B7-DDE5-26AC-08C74D168189}"/>
              </a:ext>
            </a:extLst>
          </p:cNvPr>
          <p:cNvCxnSpPr>
            <a:cxnSpLocks/>
          </p:cNvCxnSpPr>
          <p:nvPr/>
        </p:nvCxnSpPr>
        <p:spPr>
          <a:xfrm>
            <a:off x="6109524" y="1553657"/>
            <a:ext cx="377607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83E1D316-32D1-6FD3-84B7-C2461B9BA9CC}"/>
              </a:ext>
            </a:extLst>
          </p:cNvPr>
          <p:cNvSpPr txBox="1"/>
          <p:nvPr/>
        </p:nvSpPr>
        <p:spPr>
          <a:xfrm>
            <a:off x="2777519" y="5891371"/>
            <a:ext cx="15207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ystematic therapy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0AD4FF7F-0296-E00C-3F1C-8C65BFFD3A42}"/>
              </a:ext>
            </a:extLst>
          </p:cNvPr>
          <p:cNvSpPr txBox="1"/>
          <p:nvPr/>
        </p:nvSpPr>
        <p:spPr>
          <a:xfrm>
            <a:off x="2797625" y="5603766"/>
            <a:ext cx="7480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AT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0" name="直線コネクタ 109">
            <a:extLst>
              <a:ext uri="{FF2B5EF4-FFF2-40B4-BE49-F238E27FC236}">
                <a16:creationId xmlns:a16="http://schemas.microsoft.com/office/drawing/2014/main" id="{114ED831-80E3-4D78-D36E-BC522F29D545}"/>
              </a:ext>
            </a:extLst>
          </p:cNvPr>
          <p:cNvCxnSpPr>
            <a:cxnSpLocks/>
          </p:cNvCxnSpPr>
          <p:nvPr/>
        </p:nvCxnSpPr>
        <p:spPr>
          <a:xfrm>
            <a:off x="2398412" y="5745843"/>
            <a:ext cx="377607" cy="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直線コネクタ 110">
            <a:extLst>
              <a:ext uri="{FF2B5EF4-FFF2-40B4-BE49-F238E27FC236}">
                <a16:creationId xmlns:a16="http://schemas.microsoft.com/office/drawing/2014/main" id="{E9C2120C-D962-75E3-C58C-DEB5251C9073}"/>
              </a:ext>
            </a:extLst>
          </p:cNvPr>
          <p:cNvCxnSpPr>
            <a:cxnSpLocks/>
          </p:cNvCxnSpPr>
          <p:nvPr/>
        </p:nvCxnSpPr>
        <p:spPr>
          <a:xfrm>
            <a:off x="2398753" y="6028207"/>
            <a:ext cx="377607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DA2D4616-9274-29E8-DB80-297E9845B198}"/>
              </a:ext>
            </a:extLst>
          </p:cNvPr>
          <p:cNvSpPr txBox="1"/>
          <p:nvPr/>
        </p:nvSpPr>
        <p:spPr>
          <a:xfrm>
            <a:off x="6660174" y="5893134"/>
            <a:ext cx="15207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ystematic therapy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39AA48D1-4EFA-D450-6706-3F1BF31A4F5D}"/>
              </a:ext>
            </a:extLst>
          </p:cNvPr>
          <p:cNvSpPr txBox="1"/>
          <p:nvPr/>
        </p:nvSpPr>
        <p:spPr>
          <a:xfrm>
            <a:off x="6680280" y="5605529"/>
            <a:ext cx="7480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AT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4" name="直線コネクタ 113">
            <a:extLst>
              <a:ext uri="{FF2B5EF4-FFF2-40B4-BE49-F238E27FC236}">
                <a16:creationId xmlns:a16="http://schemas.microsoft.com/office/drawing/2014/main" id="{2D43736A-EE96-1B51-E94B-C81D41B6E0F9}"/>
              </a:ext>
            </a:extLst>
          </p:cNvPr>
          <p:cNvCxnSpPr>
            <a:cxnSpLocks/>
          </p:cNvCxnSpPr>
          <p:nvPr/>
        </p:nvCxnSpPr>
        <p:spPr>
          <a:xfrm>
            <a:off x="6281067" y="5747606"/>
            <a:ext cx="377607" cy="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直線コネクタ 114">
            <a:extLst>
              <a:ext uri="{FF2B5EF4-FFF2-40B4-BE49-F238E27FC236}">
                <a16:creationId xmlns:a16="http://schemas.microsoft.com/office/drawing/2014/main" id="{26238001-4349-0804-A7C8-31B5038E09DD}"/>
              </a:ext>
            </a:extLst>
          </p:cNvPr>
          <p:cNvCxnSpPr>
            <a:cxnSpLocks/>
          </p:cNvCxnSpPr>
          <p:nvPr/>
        </p:nvCxnSpPr>
        <p:spPr>
          <a:xfrm>
            <a:off x="6281408" y="6029970"/>
            <a:ext cx="377607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8E1E10C7-A8CF-2CDC-8243-68EFFBD29D0C}"/>
              </a:ext>
            </a:extLst>
          </p:cNvPr>
          <p:cNvSpPr txBox="1"/>
          <p:nvPr/>
        </p:nvSpPr>
        <p:spPr>
          <a:xfrm>
            <a:off x="4792305" y="3062820"/>
            <a:ext cx="5985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LAT</a:t>
            </a:r>
            <a:endParaRPr lang="ja-JP" altLang="en-US" sz="11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B1E6ACE0-1F01-3408-E4AB-7EBC4FACF18A}"/>
              </a:ext>
            </a:extLst>
          </p:cNvPr>
          <p:cNvSpPr txBox="1"/>
          <p:nvPr/>
        </p:nvSpPr>
        <p:spPr>
          <a:xfrm>
            <a:off x="3923827" y="3398411"/>
            <a:ext cx="13970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Systemic therapy</a:t>
            </a:r>
            <a:endParaRPr lang="ja-JP" altLang="en-US" sz="11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6071892D-DD3C-08DD-01D9-6EB448B7170D}"/>
              </a:ext>
            </a:extLst>
          </p:cNvPr>
          <p:cNvSpPr txBox="1"/>
          <p:nvPr/>
        </p:nvSpPr>
        <p:spPr>
          <a:xfrm>
            <a:off x="844082" y="8086716"/>
            <a:ext cx="5985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LAT</a:t>
            </a:r>
            <a:endParaRPr lang="ja-JP" altLang="en-US" sz="11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4F49F4B0-370E-8371-93D3-7E3A6932069B}"/>
              </a:ext>
            </a:extLst>
          </p:cNvPr>
          <p:cNvSpPr txBox="1"/>
          <p:nvPr/>
        </p:nvSpPr>
        <p:spPr>
          <a:xfrm>
            <a:off x="-31484" y="8429395"/>
            <a:ext cx="13970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Systemic therapy</a:t>
            </a:r>
            <a:endParaRPr lang="ja-JP" altLang="en-US" sz="11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CB6AC9BB-85AE-2FA1-9729-A313E607B459}"/>
              </a:ext>
            </a:extLst>
          </p:cNvPr>
          <p:cNvSpPr txBox="1"/>
          <p:nvPr/>
        </p:nvSpPr>
        <p:spPr>
          <a:xfrm>
            <a:off x="4824202" y="8090264"/>
            <a:ext cx="5985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LAT</a:t>
            </a:r>
            <a:endParaRPr lang="ja-JP" altLang="en-US" sz="11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3F77C268-FA6A-122A-0016-AEF7FC4DC6AF}"/>
              </a:ext>
            </a:extLst>
          </p:cNvPr>
          <p:cNvSpPr txBox="1"/>
          <p:nvPr/>
        </p:nvSpPr>
        <p:spPr>
          <a:xfrm>
            <a:off x="3955724" y="8432943"/>
            <a:ext cx="13970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Systemic therapy</a:t>
            </a:r>
            <a:endParaRPr lang="ja-JP" altLang="en-US" sz="11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FCBF9A7D-33C9-4885-81F4-EE19E53055A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01072087"/>
              </p:ext>
            </p:extLst>
          </p:nvPr>
        </p:nvGraphicFramePr>
        <p:xfrm>
          <a:off x="184650" y="3999724"/>
          <a:ext cx="3734439" cy="12253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67115">
                  <a:extLst>
                    <a:ext uri="{9D8B030D-6E8A-4147-A177-3AD203B41FA5}">
                      <a16:colId xmlns:a16="http://schemas.microsoft.com/office/drawing/2014/main" val="1375256391"/>
                    </a:ext>
                  </a:extLst>
                </a:gridCol>
                <a:gridCol w="1392150">
                  <a:extLst>
                    <a:ext uri="{9D8B030D-6E8A-4147-A177-3AD203B41FA5}">
                      <a16:colId xmlns:a16="http://schemas.microsoft.com/office/drawing/2014/main" val="4187723446"/>
                    </a:ext>
                  </a:extLst>
                </a:gridCol>
                <a:gridCol w="975174">
                  <a:extLst>
                    <a:ext uri="{9D8B030D-6E8A-4147-A177-3AD203B41FA5}">
                      <a16:colId xmlns:a16="http://schemas.microsoft.com/office/drawing/2014/main" val="1944230773"/>
                    </a:ext>
                  </a:extLst>
                </a:gridCol>
              </a:tblGrid>
              <a:tr h="274562">
                <a:tc>
                  <a:txBody>
                    <a:bodyPr/>
                    <a:lstStyle/>
                    <a:p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stemic therap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46686792"/>
                  </a:ext>
                </a:extLst>
              </a:tr>
              <a:tr h="34442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PFS, 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ths (95% CI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0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4.4–7.7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9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.9–12.6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450245"/>
                  </a:ext>
                </a:extLst>
              </a:tr>
              <a:tr h="26494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 (95% CI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0 (0.41-1.97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65889025"/>
                  </a:ext>
                </a:extLst>
              </a:tr>
              <a:tr h="23360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9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64376263"/>
                  </a:ext>
                </a:extLst>
              </a:tr>
            </a:tbl>
          </a:graphicData>
        </a:graphic>
      </p:graphicFrame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E731FDA0-135F-A12E-CD40-CAF1D1E7717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59283404"/>
              </p:ext>
            </p:extLst>
          </p:nvPr>
        </p:nvGraphicFramePr>
        <p:xfrm>
          <a:off x="4195370" y="3996009"/>
          <a:ext cx="3734439" cy="12253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67115">
                  <a:extLst>
                    <a:ext uri="{9D8B030D-6E8A-4147-A177-3AD203B41FA5}">
                      <a16:colId xmlns:a16="http://schemas.microsoft.com/office/drawing/2014/main" val="1375256391"/>
                    </a:ext>
                  </a:extLst>
                </a:gridCol>
                <a:gridCol w="1392150">
                  <a:extLst>
                    <a:ext uri="{9D8B030D-6E8A-4147-A177-3AD203B41FA5}">
                      <a16:colId xmlns:a16="http://schemas.microsoft.com/office/drawing/2014/main" val="4187723446"/>
                    </a:ext>
                  </a:extLst>
                </a:gridCol>
                <a:gridCol w="975174">
                  <a:extLst>
                    <a:ext uri="{9D8B030D-6E8A-4147-A177-3AD203B41FA5}">
                      <a16:colId xmlns:a16="http://schemas.microsoft.com/office/drawing/2014/main" val="1944230773"/>
                    </a:ext>
                  </a:extLst>
                </a:gridCol>
              </a:tblGrid>
              <a:tr h="274562">
                <a:tc>
                  <a:txBody>
                    <a:bodyPr/>
                    <a:lstStyle/>
                    <a:p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stemic therap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46686792"/>
                  </a:ext>
                </a:extLst>
              </a:tr>
              <a:tr h="34442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LPFS, 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ths (95% CI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7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5.5–11.2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4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.3–63.8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450245"/>
                  </a:ext>
                </a:extLst>
              </a:tr>
              <a:tr h="26494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 (95% CI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8 (0.25-1.33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65889025"/>
                  </a:ext>
                </a:extLst>
              </a:tr>
              <a:tr h="23360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9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64376263"/>
                  </a:ext>
                </a:extLst>
              </a:tr>
            </a:tbl>
          </a:graphicData>
        </a:graphic>
      </p:graphicFrame>
      <p:graphicFrame>
        <p:nvGraphicFramePr>
          <p:cNvPr id="33" name="表 32">
            <a:extLst>
              <a:ext uri="{FF2B5EF4-FFF2-40B4-BE49-F238E27FC236}">
                <a16:creationId xmlns:a16="http://schemas.microsoft.com/office/drawing/2014/main" id="{193A4295-2F02-43AA-0407-B1D4FB5031A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01873539"/>
              </p:ext>
            </p:extLst>
          </p:nvPr>
        </p:nvGraphicFramePr>
        <p:xfrm>
          <a:off x="222499" y="9036684"/>
          <a:ext cx="3734439" cy="12253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67115">
                  <a:extLst>
                    <a:ext uri="{9D8B030D-6E8A-4147-A177-3AD203B41FA5}">
                      <a16:colId xmlns:a16="http://schemas.microsoft.com/office/drawing/2014/main" val="1375256391"/>
                    </a:ext>
                  </a:extLst>
                </a:gridCol>
                <a:gridCol w="1392150">
                  <a:extLst>
                    <a:ext uri="{9D8B030D-6E8A-4147-A177-3AD203B41FA5}">
                      <a16:colId xmlns:a16="http://schemas.microsoft.com/office/drawing/2014/main" val="4187723446"/>
                    </a:ext>
                  </a:extLst>
                </a:gridCol>
                <a:gridCol w="975174">
                  <a:extLst>
                    <a:ext uri="{9D8B030D-6E8A-4147-A177-3AD203B41FA5}">
                      <a16:colId xmlns:a16="http://schemas.microsoft.com/office/drawing/2014/main" val="1944230773"/>
                    </a:ext>
                  </a:extLst>
                </a:gridCol>
              </a:tblGrid>
              <a:tr h="274562">
                <a:tc>
                  <a:txBody>
                    <a:bodyPr/>
                    <a:lstStyle/>
                    <a:p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stemic therap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46686792"/>
                  </a:ext>
                </a:extLst>
              </a:tr>
              <a:tr h="34442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OS, 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ths (95% CI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.5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63.8–NR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R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6.9–NR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450245"/>
                  </a:ext>
                </a:extLst>
              </a:tr>
              <a:tr h="26494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 (95% CI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1 (0.23-2.92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65889025"/>
                  </a:ext>
                </a:extLst>
              </a:tr>
              <a:tr h="23360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5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64376263"/>
                  </a:ext>
                </a:extLst>
              </a:tr>
            </a:tbl>
          </a:graphicData>
        </a:graphic>
      </p:graphicFrame>
      <p:graphicFrame>
        <p:nvGraphicFramePr>
          <p:cNvPr id="34" name="表 33">
            <a:extLst>
              <a:ext uri="{FF2B5EF4-FFF2-40B4-BE49-F238E27FC236}">
                <a16:creationId xmlns:a16="http://schemas.microsoft.com/office/drawing/2014/main" id="{13503F30-1512-1D27-DA5E-87BFDAE44F3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09895494"/>
              </p:ext>
            </p:extLst>
          </p:nvPr>
        </p:nvGraphicFramePr>
        <p:xfrm>
          <a:off x="4188608" y="9032970"/>
          <a:ext cx="3734439" cy="12253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67115">
                  <a:extLst>
                    <a:ext uri="{9D8B030D-6E8A-4147-A177-3AD203B41FA5}">
                      <a16:colId xmlns:a16="http://schemas.microsoft.com/office/drawing/2014/main" val="1375256391"/>
                    </a:ext>
                  </a:extLst>
                </a:gridCol>
                <a:gridCol w="1392150">
                  <a:extLst>
                    <a:ext uri="{9D8B030D-6E8A-4147-A177-3AD203B41FA5}">
                      <a16:colId xmlns:a16="http://schemas.microsoft.com/office/drawing/2014/main" val="4187723446"/>
                    </a:ext>
                  </a:extLst>
                </a:gridCol>
                <a:gridCol w="975174">
                  <a:extLst>
                    <a:ext uri="{9D8B030D-6E8A-4147-A177-3AD203B41FA5}">
                      <a16:colId xmlns:a16="http://schemas.microsoft.com/office/drawing/2014/main" val="1944230773"/>
                    </a:ext>
                  </a:extLst>
                </a:gridCol>
              </a:tblGrid>
              <a:tr h="274562">
                <a:tc>
                  <a:txBody>
                    <a:bodyPr/>
                    <a:lstStyle/>
                    <a:p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stemic therap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46686792"/>
                  </a:ext>
                </a:extLst>
              </a:tr>
              <a:tr h="34442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OP-OS, 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ths (95% CI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.8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36.9–NR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.1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.2–64.1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450245"/>
                  </a:ext>
                </a:extLst>
              </a:tr>
              <a:tr h="26494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 (95% CI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 (0.20-2.56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65889025"/>
                  </a:ext>
                </a:extLst>
              </a:tr>
              <a:tr h="23360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1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6437626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517765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03</TotalTime>
  <Words>233</Words>
  <Application>Microsoft Office PowerPoint</Application>
  <PresentationFormat>ユーザー設定</PresentationFormat>
  <Paragraphs>12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大亮 森永</dc:creator>
  <cp:lastModifiedBy>大亮 森永</cp:lastModifiedBy>
  <cp:revision>78</cp:revision>
  <dcterms:created xsi:type="dcterms:W3CDTF">2024-11-25T14:27:02Z</dcterms:created>
  <dcterms:modified xsi:type="dcterms:W3CDTF">2025-02-25T04:10:46Z</dcterms:modified>
</cp:coreProperties>
</file>